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7108" autoAdjust="0"/>
    <p:restoredTop sz="94660"/>
  </p:normalViewPr>
  <p:slideViewPr>
    <p:cSldViewPr snapToGrid="0" snapToObjects="1">
      <p:cViewPr>
        <p:scale>
          <a:sx n="100" d="100"/>
          <a:sy n="100" d="100"/>
        </p:scale>
        <p:origin x="-972" y="14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234264-663B-4C14-9238-87A58890A8FB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8EE391-FAB3-4B27-BFBF-CB640B5892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864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8EE391-FAB3-4B27-BFBF-CB640B5892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583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2777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28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9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071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67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832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647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0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13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32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271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F006F-A6D3-224E-8E4F-786A9970FF1E}" type="datetimeFigureOut">
              <a:rPr kumimoji="1" lang="ja-JP" altLang="en-US" smtClean="0"/>
              <a:t>2020/8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65953-34B3-F646-865F-EB393CF68E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880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表 85">
            <a:extLst>
              <a:ext uri="{FF2B5EF4-FFF2-40B4-BE49-F238E27FC236}">
                <a16:creationId xmlns:a16="http://schemas.microsoft.com/office/drawing/2014/main" xmlns="" id="{B2F05112-E86F-4F04-8BCC-71FB4FEFEE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8415253"/>
              </p:ext>
            </p:extLst>
          </p:nvPr>
        </p:nvGraphicFramePr>
        <p:xfrm>
          <a:off x="118702" y="6144120"/>
          <a:ext cx="3192488" cy="625070"/>
        </p:xfrm>
        <a:graphic>
          <a:graphicData uri="http://schemas.openxmlformats.org/drawingml/2006/table">
            <a:tbl>
              <a:tblPr/>
              <a:tblGrid>
                <a:gridCol w="619192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181123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99658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52303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58956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404761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76495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anced-look </a:t>
                      </a: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9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graphicFrame>
        <p:nvGraphicFramePr>
          <p:cNvPr id="76" name="表 75">
            <a:extLst>
              <a:ext uri="{FF2B5EF4-FFF2-40B4-BE49-F238E27FC236}">
                <a16:creationId xmlns:a16="http://schemas.microsoft.com/office/drawing/2014/main" xmlns="" id="{FFB188D5-5185-46A5-BA6A-0966206986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5480204"/>
              </p:ext>
            </p:extLst>
          </p:nvPr>
        </p:nvGraphicFramePr>
        <p:xfrm>
          <a:off x="93650" y="3000939"/>
          <a:ext cx="3217541" cy="625070"/>
        </p:xfrm>
        <a:graphic>
          <a:graphicData uri="http://schemas.openxmlformats.org/drawingml/2006/table">
            <a:tbl>
              <a:tblPr/>
              <a:tblGrid>
                <a:gridCol w="584873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397011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429076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55067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63343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407937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80234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look E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7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4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3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7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anced-look E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pic>
        <p:nvPicPr>
          <p:cNvPr id="14" name="図 13">
            <a:extLst>
              <a:ext uri="{FF2B5EF4-FFF2-40B4-BE49-F238E27FC236}">
                <a16:creationId xmlns:a16="http://schemas.microsoft.com/office/drawing/2014/main" xmlns="" id="{3D32EBBD-5B6E-4C83-91EB-75EC8670D0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37" t="21178" r="57500" b="30502"/>
          <a:stretch/>
        </p:blipFill>
        <p:spPr>
          <a:xfrm>
            <a:off x="846941" y="7274688"/>
            <a:ext cx="2260600" cy="144780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E7AAF346-326D-4D5D-8155-F800C2B8231E}"/>
              </a:ext>
            </a:extLst>
          </p:cNvPr>
          <p:cNvSpPr txBox="1"/>
          <p:nvPr/>
        </p:nvSpPr>
        <p:spPr>
          <a:xfrm>
            <a:off x="244914" y="197914"/>
            <a:ext cx="2311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xmlns="" id="{48533F0A-0387-45D1-9E7E-45665F89B8F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21" t="21386" r="57315" b="30448"/>
          <a:stretch/>
        </p:blipFill>
        <p:spPr>
          <a:xfrm>
            <a:off x="855826" y="1027273"/>
            <a:ext cx="2260600" cy="1447801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D97D6D62-B3CC-40B7-A482-DC81AE432CC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628" t="21692" r="57409" b="30142"/>
          <a:stretch/>
        </p:blipFill>
        <p:spPr>
          <a:xfrm>
            <a:off x="4261280" y="1031938"/>
            <a:ext cx="2260600" cy="1447801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xmlns="" id="{0D59E8AE-3FA8-474C-9120-C8790009785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537" t="21602" r="57500" b="30078"/>
          <a:stretch/>
        </p:blipFill>
        <p:spPr>
          <a:xfrm>
            <a:off x="840132" y="4130144"/>
            <a:ext cx="2276293" cy="144780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2D5F14CC-5E05-4C5F-9A49-0641AB5ABB4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908" t="21354" r="57129" b="30326"/>
          <a:stretch/>
        </p:blipFill>
        <p:spPr>
          <a:xfrm>
            <a:off x="4245587" y="4156627"/>
            <a:ext cx="2260600" cy="1447801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xmlns="" id="{A5349E65-4EFC-47E7-87C8-D33050ECE76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630" t="21142" r="57407" b="30538"/>
          <a:stretch/>
        </p:blipFill>
        <p:spPr>
          <a:xfrm>
            <a:off x="4245589" y="7274688"/>
            <a:ext cx="2260600" cy="1447802"/>
          </a:xfrm>
          <a:prstGeom prst="rect">
            <a:avLst/>
          </a:prstGeom>
        </p:spPr>
      </p:pic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xmlns="" id="{6EA76574-D6B5-48B1-8171-3DC2FE186D18}"/>
              </a:ext>
            </a:extLst>
          </p:cNvPr>
          <p:cNvCxnSpPr>
            <a:cxnSpLocks/>
          </p:cNvCxnSpPr>
          <p:nvPr/>
        </p:nvCxnSpPr>
        <p:spPr>
          <a:xfrm flipV="1">
            <a:off x="840133" y="7125647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xmlns="" id="{7DDE0766-EBDF-430E-ACCE-1BAB25582E0D}"/>
              </a:ext>
            </a:extLst>
          </p:cNvPr>
          <p:cNvCxnSpPr>
            <a:cxnSpLocks/>
          </p:cNvCxnSpPr>
          <p:nvPr/>
        </p:nvCxnSpPr>
        <p:spPr>
          <a:xfrm flipV="1">
            <a:off x="846941" y="8713169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xmlns="" id="{5A5FE2DE-AB01-43A7-A127-B7ACC1984BAD}"/>
              </a:ext>
            </a:extLst>
          </p:cNvPr>
          <p:cNvCxnSpPr>
            <a:cxnSpLocks/>
          </p:cNvCxnSpPr>
          <p:nvPr/>
        </p:nvCxnSpPr>
        <p:spPr>
          <a:xfrm flipV="1">
            <a:off x="4232405" y="7126461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xmlns="" id="{E1B17F41-04D3-40FC-B138-0E12C0674BA2}"/>
              </a:ext>
            </a:extLst>
          </p:cNvPr>
          <p:cNvCxnSpPr>
            <a:cxnSpLocks/>
          </p:cNvCxnSpPr>
          <p:nvPr/>
        </p:nvCxnSpPr>
        <p:spPr>
          <a:xfrm flipV="1">
            <a:off x="4232407" y="8760997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xmlns="" id="{70A66708-3D5E-4C62-AA6D-CFABB0B15744}"/>
              </a:ext>
            </a:extLst>
          </p:cNvPr>
          <p:cNvSpPr/>
          <p:nvPr/>
        </p:nvSpPr>
        <p:spPr>
          <a:xfrm rot="16200000">
            <a:off x="-537902" y="7832587"/>
            <a:ext cx="189667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xmlns="" id="{AF3DF2EF-546A-44C6-B1A5-113F6E42398F}"/>
              </a:ext>
            </a:extLst>
          </p:cNvPr>
          <p:cNvSpPr/>
          <p:nvPr/>
        </p:nvSpPr>
        <p:spPr>
          <a:xfrm>
            <a:off x="1540656" y="8999650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DD6D0E9B-F8F8-463B-8D1D-3C8ECAB9B9CF}"/>
              </a:ext>
            </a:extLst>
          </p:cNvPr>
          <p:cNvSpPr txBox="1"/>
          <p:nvPr/>
        </p:nvSpPr>
        <p:spPr>
          <a:xfrm>
            <a:off x="400071" y="7274688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DBEA78FB-CBC8-43EB-98A3-EAACF366FBF0}"/>
              </a:ext>
            </a:extLst>
          </p:cNvPr>
          <p:cNvSpPr txBox="1"/>
          <p:nvPr/>
        </p:nvSpPr>
        <p:spPr>
          <a:xfrm>
            <a:off x="713131" y="8801974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xmlns="" id="{AF021D96-8D3F-4E98-81D5-26BA62AAA072}"/>
              </a:ext>
            </a:extLst>
          </p:cNvPr>
          <p:cNvCxnSpPr>
            <a:cxnSpLocks/>
          </p:cNvCxnSpPr>
          <p:nvPr/>
        </p:nvCxnSpPr>
        <p:spPr>
          <a:xfrm flipV="1">
            <a:off x="840131" y="4003918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xmlns="" id="{2DAEAA3E-5D3B-4F78-9276-63FA528831F4}"/>
              </a:ext>
            </a:extLst>
          </p:cNvPr>
          <p:cNvCxnSpPr>
            <a:cxnSpLocks/>
          </p:cNvCxnSpPr>
          <p:nvPr/>
        </p:nvCxnSpPr>
        <p:spPr>
          <a:xfrm flipV="1">
            <a:off x="846939" y="5638861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xmlns="" id="{BD5AAC25-A98A-4EDF-B700-C881B41F944D}"/>
              </a:ext>
            </a:extLst>
          </p:cNvPr>
          <p:cNvSpPr/>
          <p:nvPr/>
        </p:nvSpPr>
        <p:spPr>
          <a:xfrm rot="16200000">
            <a:off x="-537904" y="4710858"/>
            <a:ext cx="189667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xmlns="" id="{4FD73D62-498D-4023-A803-9C4BC8D0B474}"/>
              </a:ext>
            </a:extLst>
          </p:cNvPr>
          <p:cNvSpPr/>
          <p:nvPr/>
        </p:nvSpPr>
        <p:spPr>
          <a:xfrm>
            <a:off x="1540654" y="5877921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1D00C6AD-8EBB-43C3-9520-C2ADD4EDD3FF}"/>
              </a:ext>
            </a:extLst>
          </p:cNvPr>
          <p:cNvSpPr txBox="1"/>
          <p:nvPr/>
        </p:nvSpPr>
        <p:spPr>
          <a:xfrm>
            <a:off x="400069" y="4152959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8D77EF06-EA3D-4AC4-93A4-29EDE16ADCBC}"/>
              </a:ext>
            </a:extLst>
          </p:cNvPr>
          <p:cNvSpPr txBox="1"/>
          <p:nvPr/>
        </p:nvSpPr>
        <p:spPr>
          <a:xfrm>
            <a:off x="713129" y="5680245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xmlns="" id="{6017AEB2-A354-406E-BBD5-7F9172BA634B}"/>
              </a:ext>
            </a:extLst>
          </p:cNvPr>
          <p:cNvSpPr/>
          <p:nvPr/>
        </p:nvSpPr>
        <p:spPr>
          <a:xfrm>
            <a:off x="4927257" y="8995983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F3A599B0-D880-460C-80E4-54BC3BD52CAA}"/>
              </a:ext>
            </a:extLst>
          </p:cNvPr>
          <p:cNvSpPr txBox="1"/>
          <p:nvPr/>
        </p:nvSpPr>
        <p:spPr>
          <a:xfrm>
            <a:off x="3786672" y="7271021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2C256588-BEAF-4AA1-ACDC-04E56FFDBE9C}"/>
              </a:ext>
            </a:extLst>
          </p:cNvPr>
          <p:cNvSpPr txBox="1"/>
          <p:nvPr/>
        </p:nvSpPr>
        <p:spPr>
          <a:xfrm>
            <a:off x="4099732" y="8798307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xmlns="" id="{17C79117-F833-42A2-AA33-B9792E90A799}"/>
              </a:ext>
            </a:extLst>
          </p:cNvPr>
          <p:cNvSpPr/>
          <p:nvPr/>
        </p:nvSpPr>
        <p:spPr>
          <a:xfrm rot="16200000">
            <a:off x="2935327" y="7841633"/>
            <a:ext cx="1669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xmlns="" id="{67674962-DA51-4DF9-A90C-70B0DD091D26}"/>
              </a:ext>
            </a:extLst>
          </p:cNvPr>
          <p:cNvCxnSpPr>
            <a:cxnSpLocks/>
          </p:cNvCxnSpPr>
          <p:nvPr/>
        </p:nvCxnSpPr>
        <p:spPr>
          <a:xfrm flipV="1">
            <a:off x="4232403" y="4008399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xmlns="" id="{AA48B44F-A818-428A-8DA6-4DA2655DAAEC}"/>
              </a:ext>
            </a:extLst>
          </p:cNvPr>
          <p:cNvCxnSpPr>
            <a:cxnSpLocks/>
          </p:cNvCxnSpPr>
          <p:nvPr/>
        </p:nvCxnSpPr>
        <p:spPr>
          <a:xfrm flipV="1">
            <a:off x="4232405" y="5642935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xmlns="" id="{ECC02785-B885-4A5F-A174-FE62C8E8DCFA}"/>
              </a:ext>
            </a:extLst>
          </p:cNvPr>
          <p:cNvSpPr/>
          <p:nvPr/>
        </p:nvSpPr>
        <p:spPr>
          <a:xfrm>
            <a:off x="4927255" y="5877921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C320BB4D-E4BB-4470-9C83-9282294EA4B0}"/>
              </a:ext>
            </a:extLst>
          </p:cNvPr>
          <p:cNvSpPr txBox="1"/>
          <p:nvPr/>
        </p:nvSpPr>
        <p:spPr>
          <a:xfrm>
            <a:off x="3786670" y="4152959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E2688D88-0351-4BA4-8943-10C84B74AA10}"/>
              </a:ext>
            </a:extLst>
          </p:cNvPr>
          <p:cNvSpPr txBox="1"/>
          <p:nvPr/>
        </p:nvSpPr>
        <p:spPr>
          <a:xfrm>
            <a:off x="4099730" y="5680245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xmlns="" id="{C9C87684-E4F4-40FF-B8CB-E743F4B10C06}"/>
              </a:ext>
            </a:extLst>
          </p:cNvPr>
          <p:cNvSpPr/>
          <p:nvPr/>
        </p:nvSpPr>
        <p:spPr>
          <a:xfrm rot="16200000">
            <a:off x="2935325" y="4723571"/>
            <a:ext cx="1669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xmlns="" id="{E559B06D-BBBF-4E70-95C0-110B4FB6639C}"/>
              </a:ext>
            </a:extLst>
          </p:cNvPr>
          <p:cNvCxnSpPr>
            <a:cxnSpLocks/>
          </p:cNvCxnSpPr>
          <p:nvPr/>
        </p:nvCxnSpPr>
        <p:spPr>
          <a:xfrm flipV="1">
            <a:off x="4248096" y="883710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xmlns="" id="{E4CD3497-1312-43B6-8CDD-8906CA9F035C}"/>
              </a:ext>
            </a:extLst>
          </p:cNvPr>
          <p:cNvCxnSpPr>
            <a:cxnSpLocks/>
          </p:cNvCxnSpPr>
          <p:nvPr/>
        </p:nvCxnSpPr>
        <p:spPr>
          <a:xfrm flipV="1">
            <a:off x="4248098" y="2518246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xmlns="" id="{FB814C50-E345-4A32-9CA1-FC75CA728172}"/>
              </a:ext>
            </a:extLst>
          </p:cNvPr>
          <p:cNvSpPr/>
          <p:nvPr/>
        </p:nvSpPr>
        <p:spPr>
          <a:xfrm>
            <a:off x="4942948" y="2753232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EA8EF69E-95D4-4F17-A73A-9506A4005177}"/>
              </a:ext>
            </a:extLst>
          </p:cNvPr>
          <p:cNvSpPr txBox="1"/>
          <p:nvPr/>
        </p:nvSpPr>
        <p:spPr>
          <a:xfrm>
            <a:off x="3802363" y="1028270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FAC7D451-A9C0-4B4B-803E-6FB2B7A3B816}"/>
              </a:ext>
            </a:extLst>
          </p:cNvPr>
          <p:cNvSpPr txBox="1"/>
          <p:nvPr/>
        </p:nvSpPr>
        <p:spPr>
          <a:xfrm>
            <a:off x="4115423" y="2555556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xmlns="" id="{08131054-FFC7-46E3-B87F-C370309D16C4}"/>
              </a:ext>
            </a:extLst>
          </p:cNvPr>
          <p:cNvSpPr/>
          <p:nvPr/>
        </p:nvSpPr>
        <p:spPr>
          <a:xfrm rot="16200000">
            <a:off x="2951018" y="1598882"/>
            <a:ext cx="16690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xmlns="" id="{807A2ECA-EAD9-4C7C-BBF9-3DD8DCBB608F}"/>
              </a:ext>
            </a:extLst>
          </p:cNvPr>
          <p:cNvCxnSpPr>
            <a:cxnSpLocks/>
          </p:cNvCxnSpPr>
          <p:nvPr/>
        </p:nvCxnSpPr>
        <p:spPr>
          <a:xfrm flipV="1">
            <a:off x="855824" y="881707"/>
            <a:ext cx="2" cy="1634943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xmlns="" id="{BE5BD84F-2BBC-4DAC-88D6-A36C3D7E1049}"/>
              </a:ext>
            </a:extLst>
          </p:cNvPr>
          <p:cNvCxnSpPr>
            <a:cxnSpLocks/>
          </p:cNvCxnSpPr>
          <p:nvPr/>
        </p:nvCxnSpPr>
        <p:spPr>
          <a:xfrm flipV="1">
            <a:off x="862632" y="2516650"/>
            <a:ext cx="2253794" cy="40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xmlns="" id="{AAD58F62-19CC-44C8-AC2A-15C8751DB5A1}"/>
              </a:ext>
            </a:extLst>
          </p:cNvPr>
          <p:cNvSpPr/>
          <p:nvPr/>
        </p:nvSpPr>
        <p:spPr>
          <a:xfrm rot="16200000">
            <a:off x="-522211" y="1588647"/>
            <a:ext cx="189667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pse free survival probability (%)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xmlns="" id="{742DBC3C-8AB5-48AD-9CF4-F495262DA025}"/>
              </a:ext>
            </a:extLst>
          </p:cNvPr>
          <p:cNvSpPr/>
          <p:nvPr/>
        </p:nvSpPr>
        <p:spPr>
          <a:xfrm>
            <a:off x="1556347" y="2755710"/>
            <a:ext cx="1146468" cy="2300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Years after</a:t>
            </a:r>
            <a:r>
              <a:rPr lang="ja-JP" altLang="en-US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895" b="1" dirty="0">
                <a:latin typeface="Times New Roman" panose="02020603050405020304" pitchFamily="18" charset="0"/>
                <a:ea typeface="Yu Gothic" panose="020B0400000000000000" pitchFamily="50" charset="-128"/>
                <a:cs typeface="Times New Roman" panose="02020603050405020304" pitchFamily="18" charset="0"/>
              </a:rPr>
              <a:t>surgery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AD9546A7-7C1D-47F1-949A-C66E62A8738B}"/>
              </a:ext>
            </a:extLst>
          </p:cNvPr>
          <p:cNvSpPr txBox="1"/>
          <p:nvPr/>
        </p:nvSpPr>
        <p:spPr>
          <a:xfrm>
            <a:off x="415762" y="1030748"/>
            <a:ext cx="400403" cy="1618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endParaRPr lang="en-US" altLang="ja-JP" sz="8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5A8AF9B9-4A9C-4257-8B98-AC2212A0B2F4}"/>
              </a:ext>
            </a:extLst>
          </p:cNvPr>
          <p:cNvSpPr txBox="1"/>
          <p:nvPr/>
        </p:nvSpPr>
        <p:spPr>
          <a:xfrm>
            <a:off x="728822" y="2558034"/>
            <a:ext cx="3657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 </a:t>
            </a:r>
            <a:r>
              <a:rPr lang="en-US" altLang="ja-JP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xmlns="" id="{78F5A717-5934-4677-BF05-CCEBD55E30E3}"/>
              </a:ext>
            </a:extLst>
          </p:cNvPr>
          <p:cNvCxnSpPr>
            <a:cxnSpLocks/>
          </p:cNvCxnSpPr>
          <p:nvPr/>
        </p:nvCxnSpPr>
        <p:spPr>
          <a:xfrm>
            <a:off x="1369245" y="2067540"/>
            <a:ext cx="567254" cy="1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xmlns="" id="{18DF87E5-1E79-44BC-8A58-F58DC2878823}"/>
              </a:ext>
            </a:extLst>
          </p:cNvPr>
          <p:cNvCxnSpPr>
            <a:cxnSpLocks/>
          </p:cNvCxnSpPr>
          <p:nvPr/>
        </p:nvCxnSpPr>
        <p:spPr>
          <a:xfrm>
            <a:off x="1371040" y="2369692"/>
            <a:ext cx="567252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2366132C-E50F-43D9-8930-557D37D95C89}"/>
              </a:ext>
            </a:extLst>
          </p:cNvPr>
          <p:cNvSpPr txBox="1"/>
          <p:nvPr/>
        </p:nvSpPr>
        <p:spPr>
          <a:xfrm>
            <a:off x="1987884" y="1944427"/>
            <a:ext cx="1630654" cy="519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EGC</a:t>
            </a:r>
          </a:p>
          <a:p>
            <a:endParaRPr lang="en-US" altLang="ja-JP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EGC</a:t>
            </a: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xmlns="" id="{C81C2ABB-6A31-40EB-BBE1-5BFEC2A8C13E}"/>
              </a:ext>
            </a:extLst>
          </p:cNvPr>
          <p:cNvCxnSpPr>
            <a:cxnSpLocks/>
          </p:cNvCxnSpPr>
          <p:nvPr/>
        </p:nvCxnSpPr>
        <p:spPr>
          <a:xfrm>
            <a:off x="4801403" y="2063261"/>
            <a:ext cx="567254" cy="1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xmlns="" id="{7FBE93E2-0005-4AF5-BEB4-41E5C47CD4BE}"/>
              </a:ext>
            </a:extLst>
          </p:cNvPr>
          <p:cNvCxnSpPr>
            <a:cxnSpLocks/>
          </p:cNvCxnSpPr>
          <p:nvPr/>
        </p:nvCxnSpPr>
        <p:spPr>
          <a:xfrm>
            <a:off x="4803198" y="2365413"/>
            <a:ext cx="567252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xmlns="" id="{0328BF44-F470-490C-8053-59D5B1BE1AFF}"/>
              </a:ext>
            </a:extLst>
          </p:cNvPr>
          <p:cNvSpPr/>
          <p:nvPr/>
        </p:nvSpPr>
        <p:spPr>
          <a:xfrm>
            <a:off x="1886876" y="5089165"/>
            <a:ext cx="162516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AGC</a:t>
            </a:r>
          </a:p>
          <a:p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AGC</a:t>
            </a:r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xmlns="" id="{20E14F5D-35AF-4320-BC50-A4D1AAEA955B}"/>
              </a:ext>
            </a:extLst>
          </p:cNvPr>
          <p:cNvCxnSpPr>
            <a:cxnSpLocks/>
          </p:cNvCxnSpPr>
          <p:nvPr/>
        </p:nvCxnSpPr>
        <p:spPr>
          <a:xfrm>
            <a:off x="1329006" y="5224294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xmlns="" id="{7F8C917F-B427-4008-9CEE-A038E5730F1D}"/>
              </a:ext>
            </a:extLst>
          </p:cNvPr>
          <p:cNvCxnSpPr>
            <a:cxnSpLocks/>
          </p:cNvCxnSpPr>
          <p:nvPr/>
        </p:nvCxnSpPr>
        <p:spPr>
          <a:xfrm>
            <a:off x="1329008" y="5511098"/>
            <a:ext cx="567252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xmlns="" id="{0FC0D363-886F-4BA9-933E-0800F5C5CF86}"/>
              </a:ext>
            </a:extLst>
          </p:cNvPr>
          <p:cNvSpPr/>
          <p:nvPr/>
        </p:nvSpPr>
        <p:spPr>
          <a:xfrm>
            <a:off x="5208385" y="5048132"/>
            <a:ext cx="1690261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AGC</a:t>
            </a:r>
          </a:p>
          <a:p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AGC</a:t>
            </a: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xmlns="" id="{B3F6D2FC-5FB7-4EB3-A873-15BFF7350F0B}"/>
              </a:ext>
            </a:extLst>
          </p:cNvPr>
          <p:cNvCxnSpPr>
            <a:cxnSpLocks/>
          </p:cNvCxnSpPr>
          <p:nvPr/>
        </p:nvCxnSpPr>
        <p:spPr>
          <a:xfrm>
            <a:off x="4650515" y="5183261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xmlns="" id="{E5123FC4-D3D3-4529-AE07-E0F5069A116D}"/>
              </a:ext>
            </a:extLst>
          </p:cNvPr>
          <p:cNvCxnSpPr>
            <a:cxnSpLocks/>
          </p:cNvCxnSpPr>
          <p:nvPr/>
        </p:nvCxnSpPr>
        <p:spPr>
          <a:xfrm>
            <a:off x="4650517" y="5470065"/>
            <a:ext cx="567252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xmlns="" id="{9B7AA8D0-0201-4D82-9D94-0C688CC89DE2}"/>
              </a:ext>
            </a:extLst>
          </p:cNvPr>
          <p:cNvSpPr/>
          <p:nvPr/>
        </p:nvSpPr>
        <p:spPr>
          <a:xfrm>
            <a:off x="1882465" y="8155964"/>
            <a:ext cx="169271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AGC</a:t>
            </a:r>
          </a:p>
          <a:p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AGC</a:t>
            </a:r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xmlns="" id="{75545E2A-7CA8-4E92-8E65-130E72BF0498}"/>
              </a:ext>
            </a:extLst>
          </p:cNvPr>
          <p:cNvCxnSpPr>
            <a:cxnSpLocks/>
          </p:cNvCxnSpPr>
          <p:nvPr/>
        </p:nvCxnSpPr>
        <p:spPr>
          <a:xfrm>
            <a:off x="1324595" y="8291093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xmlns="" id="{CB1DD4E6-C90C-41A8-ADE8-6540EB82C5CA}"/>
              </a:ext>
            </a:extLst>
          </p:cNvPr>
          <p:cNvCxnSpPr>
            <a:cxnSpLocks/>
          </p:cNvCxnSpPr>
          <p:nvPr/>
        </p:nvCxnSpPr>
        <p:spPr>
          <a:xfrm>
            <a:off x="1324597" y="8577897"/>
            <a:ext cx="567252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xmlns="" id="{941773AB-A4CA-45B7-B074-084EFF623DC0}"/>
              </a:ext>
            </a:extLst>
          </p:cNvPr>
          <p:cNvSpPr/>
          <p:nvPr/>
        </p:nvSpPr>
        <p:spPr>
          <a:xfrm>
            <a:off x="5203410" y="8154328"/>
            <a:ext cx="170469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AGC</a:t>
            </a:r>
          </a:p>
          <a:p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AGC</a:t>
            </a:r>
          </a:p>
          <a:p>
            <a:pPr lvl="0" fontAlgn="b">
              <a:spcBef>
                <a:spcPct val="0"/>
              </a:spcBef>
              <a:spcAft>
                <a:spcPct val="0"/>
              </a:spcAft>
              <a:defRPr/>
            </a:pPr>
            <a:endPara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xmlns="" id="{84DA53C1-1D0B-45E5-9EB3-17C06FE18B9B}"/>
              </a:ext>
            </a:extLst>
          </p:cNvPr>
          <p:cNvCxnSpPr>
            <a:cxnSpLocks/>
          </p:cNvCxnSpPr>
          <p:nvPr/>
        </p:nvCxnSpPr>
        <p:spPr>
          <a:xfrm>
            <a:off x="4645540" y="8289457"/>
            <a:ext cx="567254" cy="1"/>
          </a:xfrm>
          <a:prstGeom prst="line">
            <a:avLst/>
          </a:prstGeom>
          <a:ln w="19050">
            <a:solidFill>
              <a:schemeClr val="tx1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xmlns="" id="{C0F06AB1-5E27-445E-AE87-0DE1DD42A0E9}"/>
              </a:ext>
            </a:extLst>
          </p:cNvPr>
          <p:cNvCxnSpPr>
            <a:cxnSpLocks/>
          </p:cNvCxnSpPr>
          <p:nvPr/>
        </p:nvCxnSpPr>
        <p:spPr>
          <a:xfrm>
            <a:off x="4645542" y="8576261"/>
            <a:ext cx="567252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D2D873AA-767F-4605-84D3-113C8EB3DC6A}"/>
              </a:ext>
            </a:extLst>
          </p:cNvPr>
          <p:cNvSpPr txBox="1"/>
          <p:nvPr/>
        </p:nvSpPr>
        <p:spPr>
          <a:xfrm>
            <a:off x="217761" y="490170"/>
            <a:ext cx="796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AA6439CC-5525-44AC-BBA7-B216A71FEF6E}"/>
              </a:ext>
            </a:extLst>
          </p:cNvPr>
          <p:cNvSpPr txBox="1"/>
          <p:nvPr/>
        </p:nvSpPr>
        <p:spPr>
          <a:xfrm>
            <a:off x="229321" y="3615101"/>
            <a:ext cx="9066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C799955D-A52C-4BB1-8771-2E0C5F2B4BA6}"/>
              </a:ext>
            </a:extLst>
          </p:cNvPr>
          <p:cNvSpPr txBox="1"/>
          <p:nvPr/>
        </p:nvSpPr>
        <p:spPr>
          <a:xfrm>
            <a:off x="250406" y="6771541"/>
            <a:ext cx="8855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II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960A40AF-CDA0-4717-8F16-AE187095FB86}"/>
              </a:ext>
            </a:extLst>
          </p:cNvPr>
          <p:cNvSpPr txBox="1"/>
          <p:nvPr/>
        </p:nvSpPr>
        <p:spPr>
          <a:xfrm>
            <a:off x="730" y="2788829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DF54769B-B568-4F98-A1F2-97006CF83D48}"/>
              </a:ext>
            </a:extLst>
          </p:cNvPr>
          <p:cNvSpPr txBox="1"/>
          <p:nvPr/>
        </p:nvSpPr>
        <p:spPr>
          <a:xfrm>
            <a:off x="3371640" y="2797930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2" name="表 81">
            <a:extLst>
              <a:ext uri="{FF2B5EF4-FFF2-40B4-BE49-F238E27FC236}">
                <a16:creationId xmlns:a16="http://schemas.microsoft.com/office/drawing/2014/main" xmlns="" id="{546CCB41-CFC0-4FC0-8E7B-46021A1DB3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1044094"/>
              </p:ext>
            </p:extLst>
          </p:nvPr>
        </p:nvGraphicFramePr>
        <p:xfrm>
          <a:off x="3521271" y="3004273"/>
          <a:ext cx="3185156" cy="625070"/>
        </p:xfrm>
        <a:graphic>
          <a:graphicData uri="http://schemas.openxmlformats.org/drawingml/2006/table">
            <a:tbl>
              <a:tblPr/>
              <a:tblGrid>
                <a:gridCol w="589512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307714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73526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36950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34599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387123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55732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look E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7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anced-look E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932B4A2E-0BA5-44BB-B61C-4D8661EC5573}"/>
              </a:ext>
            </a:extLst>
          </p:cNvPr>
          <p:cNvSpPr txBox="1"/>
          <p:nvPr/>
        </p:nvSpPr>
        <p:spPr>
          <a:xfrm>
            <a:off x="5428986" y="1944427"/>
            <a:ext cx="1630654" cy="5193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-look EGC</a:t>
            </a:r>
          </a:p>
          <a:p>
            <a:endParaRPr lang="en-US" altLang="ja-JP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fontAlgn="b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anced-look EGC</a:t>
            </a:r>
          </a:p>
        </p:txBody>
      </p:sp>
      <p:graphicFrame>
        <p:nvGraphicFramePr>
          <p:cNvPr id="84" name="表 83">
            <a:extLst>
              <a:ext uri="{FF2B5EF4-FFF2-40B4-BE49-F238E27FC236}">
                <a16:creationId xmlns:a16="http://schemas.microsoft.com/office/drawing/2014/main" xmlns="" id="{6A19A9D8-D87D-458A-93FC-392FFEE31E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6927247"/>
              </p:ext>
            </p:extLst>
          </p:nvPr>
        </p:nvGraphicFramePr>
        <p:xfrm>
          <a:off x="3516217" y="6144065"/>
          <a:ext cx="3190212" cy="625070"/>
        </p:xfrm>
        <a:graphic>
          <a:graphicData uri="http://schemas.openxmlformats.org/drawingml/2006/table">
            <a:tbl>
              <a:tblPr/>
              <a:tblGrid>
                <a:gridCol w="625621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174123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99230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52051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58559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404472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76156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anced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290E31E5-C07A-4F9A-9C7E-CDE90B212D79}"/>
              </a:ext>
            </a:extLst>
          </p:cNvPr>
          <p:cNvSpPr txBox="1"/>
          <p:nvPr/>
        </p:nvSpPr>
        <p:spPr>
          <a:xfrm>
            <a:off x="3383231" y="5918334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98771939-1728-46CA-AE89-006718B59D5C}"/>
              </a:ext>
            </a:extLst>
          </p:cNvPr>
          <p:cNvSpPr txBox="1"/>
          <p:nvPr/>
        </p:nvSpPr>
        <p:spPr>
          <a:xfrm>
            <a:off x="50104" y="5956841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8" name="表 87">
            <a:extLst>
              <a:ext uri="{FF2B5EF4-FFF2-40B4-BE49-F238E27FC236}">
                <a16:creationId xmlns:a16="http://schemas.microsoft.com/office/drawing/2014/main" xmlns="" id="{BE4B7EB2-A1E6-4A79-BE42-4416DF58F1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2768314"/>
              </p:ext>
            </p:extLst>
          </p:nvPr>
        </p:nvGraphicFramePr>
        <p:xfrm>
          <a:off x="81123" y="9238076"/>
          <a:ext cx="3302108" cy="625070"/>
        </p:xfrm>
        <a:graphic>
          <a:graphicData uri="http://schemas.openxmlformats.org/drawingml/2006/table">
            <a:tbl>
              <a:tblPr/>
              <a:tblGrid>
                <a:gridCol w="646058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181737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620248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64400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78149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418660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92856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anced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3DD305FD-ED7C-4FAE-A7D8-12D1808C85DA}"/>
              </a:ext>
            </a:extLst>
          </p:cNvPr>
          <p:cNvSpPr txBox="1"/>
          <p:nvPr/>
        </p:nvSpPr>
        <p:spPr>
          <a:xfrm>
            <a:off x="50104" y="9050797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0" name="表 89">
            <a:extLst>
              <a:ext uri="{FF2B5EF4-FFF2-40B4-BE49-F238E27FC236}">
                <a16:creationId xmlns:a16="http://schemas.microsoft.com/office/drawing/2014/main" xmlns="" id="{9A5343AB-9243-4F4A-A318-D1B44D3F95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1604512"/>
              </p:ext>
            </p:extLst>
          </p:nvPr>
        </p:nvGraphicFramePr>
        <p:xfrm>
          <a:off x="3512349" y="9236005"/>
          <a:ext cx="3194080" cy="625070"/>
        </p:xfrm>
        <a:graphic>
          <a:graphicData uri="http://schemas.openxmlformats.org/drawingml/2006/table">
            <a:tbl>
              <a:tblPr/>
              <a:tblGrid>
                <a:gridCol w="589136">
                  <a:extLst>
                    <a:ext uri="{9D8B030D-6E8A-4147-A177-3AD203B41FA5}">
                      <a16:colId xmlns:a16="http://schemas.microsoft.com/office/drawing/2014/main" xmlns="" val="1319396299"/>
                    </a:ext>
                  </a:extLst>
                </a:gridCol>
                <a:gridCol w="211578">
                  <a:extLst>
                    <a:ext uri="{9D8B030D-6E8A-4147-A177-3AD203B41FA5}">
                      <a16:colId xmlns:a16="http://schemas.microsoft.com/office/drawing/2014/main" xmlns="" val="3362648655"/>
                    </a:ext>
                  </a:extLst>
                </a:gridCol>
                <a:gridCol w="599957">
                  <a:extLst>
                    <a:ext uri="{9D8B030D-6E8A-4147-A177-3AD203B41FA5}">
                      <a16:colId xmlns:a16="http://schemas.microsoft.com/office/drawing/2014/main" xmlns="" val="1302385844"/>
                    </a:ext>
                  </a:extLst>
                </a:gridCol>
                <a:gridCol w="352479">
                  <a:extLst>
                    <a:ext uri="{9D8B030D-6E8A-4147-A177-3AD203B41FA5}">
                      <a16:colId xmlns:a16="http://schemas.microsoft.com/office/drawing/2014/main" xmlns="" val="333188100"/>
                    </a:ext>
                  </a:extLst>
                </a:gridCol>
                <a:gridCol w="559235">
                  <a:extLst>
                    <a:ext uri="{9D8B030D-6E8A-4147-A177-3AD203B41FA5}">
                      <a16:colId xmlns:a16="http://schemas.microsoft.com/office/drawing/2014/main" xmlns="" val="3683313437"/>
                    </a:ext>
                  </a:extLst>
                </a:gridCol>
                <a:gridCol w="404962">
                  <a:extLst>
                    <a:ext uri="{9D8B030D-6E8A-4147-A177-3AD203B41FA5}">
                      <a16:colId xmlns:a16="http://schemas.microsoft.com/office/drawing/2014/main" xmlns="" val="3584551713"/>
                    </a:ext>
                  </a:extLst>
                </a:gridCol>
                <a:gridCol w="476733">
                  <a:extLst>
                    <a:ext uri="{9D8B030D-6E8A-4147-A177-3AD203B41FA5}">
                      <a16:colId xmlns:a16="http://schemas.microsoft.com/office/drawing/2014/main" xmlns="" val="3222050329"/>
                    </a:ext>
                  </a:extLst>
                </a:gridCol>
              </a:tblGrid>
              <a:tr h="186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63036091"/>
                  </a:ext>
                </a:extLst>
              </a:tr>
              <a:tr h="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anced-look AGC</a:t>
                      </a:r>
                    </a:p>
                  </a:txBody>
                  <a:tcPr marL="4660" marR="4660" marT="4660" marB="33555" anchor="ctr" horzOverflow="overflow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8</a:t>
                      </a:r>
                    </a:p>
                  </a:txBody>
                  <a:tcPr marL="5159" marR="5159" marT="5159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00314064"/>
                  </a:ext>
                </a:extLst>
              </a:tr>
            </a:tbl>
          </a:graphicData>
        </a:graphic>
      </p:graphicFrame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51EF0164-82F3-4C8B-8BAA-45C338F00BA8}"/>
              </a:ext>
            </a:extLst>
          </p:cNvPr>
          <p:cNvSpPr txBox="1"/>
          <p:nvPr/>
        </p:nvSpPr>
        <p:spPr>
          <a:xfrm>
            <a:off x="3371375" y="9048726"/>
            <a:ext cx="1456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4D7489ED-E51C-4E49-9BB9-C10231664958}"/>
              </a:ext>
            </a:extLst>
          </p:cNvPr>
          <p:cNvGrpSpPr/>
          <p:nvPr/>
        </p:nvGrpSpPr>
        <p:grpSpPr>
          <a:xfrm>
            <a:off x="6562021" y="1084152"/>
            <a:ext cx="401043" cy="317395"/>
            <a:chOff x="6522987" y="1002751"/>
            <a:chExt cx="446844" cy="484914"/>
          </a:xfrm>
        </p:grpSpPr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xmlns="" id="{EEE2E198-D666-4A42-9EDB-DAFC4FF454BF}"/>
                </a:ext>
              </a:extLst>
            </p:cNvPr>
            <p:cNvGrpSpPr/>
            <p:nvPr/>
          </p:nvGrpSpPr>
          <p:grpSpPr>
            <a:xfrm>
              <a:off x="6522987" y="1112596"/>
              <a:ext cx="140524" cy="229732"/>
              <a:chOff x="5593711" y="5353149"/>
              <a:chExt cx="120659" cy="375023"/>
            </a:xfrm>
          </p:grpSpPr>
          <p:cxnSp>
            <p:nvCxnSpPr>
              <p:cNvPr id="98" name="直線コネクタ 97">
                <a:extLst>
                  <a:ext uri="{FF2B5EF4-FFF2-40B4-BE49-F238E27FC236}">
                    <a16:creationId xmlns:a16="http://schemas.microsoft.com/office/drawing/2014/main" xmlns="" id="{539218D7-C69F-4D1B-A053-A671F80776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14365" y="5353149"/>
                <a:ext cx="0" cy="3750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xmlns="" id="{81E3EE8E-07D1-4F3A-8E3D-D3C009777C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97947" y="5353374"/>
                <a:ext cx="11642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線コネクタ 99">
                <a:extLst>
                  <a:ext uri="{FF2B5EF4-FFF2-40B4-BE49-F238E27FC236}">
                    <a16:creationId xmlns:a16="http://schemas.microsoft.com/office/drawing/2014/main" xmlns="" id="{01FE1251-9D14-46D3-8E0B-C487BDC527D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93711" y="5728171"/>
                <a:ext cx="120659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xmlns="" id="{09554DA5-9BF7-42CA-89DE-800311E596C5}"/>
                </a:ext>
              </a:extLst>
            </p:cNvPr>
            <p:cNvSpPr txBox="1"/>
            <p:nvPr/>
          </p:nvSpPr>
          <p:spPr>
            <a:xfrm>
              <a:off x="6593249" y="1002751"/>
              <a:ext cx="376582" cy="48491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ja-JP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73076557-1E9F-43DF-BCAF-631B087C7B34}"/>
              </a:ext>
            </a:extLst>
          </p:cNvPr>
          <p:cNvSpPr txBox="1"/>
          <p:nvPr/>
        </p:nvSpPr>
        <p:spPr>
          <a:xfrm>
            <a:off x="2141056" y="1444087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xmlns="" id="{7D6DE3C6-B93B-4DC6-ABDE-299DC33F51D0}"/>
              </a:ext>
            </a:extLst>
          </p:cNvPr>
          <p:cNvGrpSpPr/>
          <p:nvPr/>
        </p:nvGrpSpPr>
        <p:grpSpPr>
          <a:xfrm>
            <a:off x="3161753" y="1159173"/>
            <a:ext cx="488477" cy="242374"/>
            <a:chOff x="6522987" y="1080710"/>
            <a:chExt cx="476509" cy="318760"/>
          </a:xfrm>
        </p:grpSpPr>
        <p:grpSp>
          <p:nvGrpSpPr>
            <p:cNvPr id="110" name="グループ化 109">
              <a:extLst>
                <a:ext uri="{FF2B5EF4-FFF2-40B4-BE49-F238E27FC236}">
                  <a16:creationId xmlns:a16="http://schemas.microsoft.com/office/drawing/2014/main" xmlns="" id="{06126240-E1BD-49A2-BCAD-599E96D1CE41}"/>
                </a:ext>
              </a:extLst>
            </p:cNvPr>
            <p:cNvGrpSpPr/>
            <p:nvPr/>
          </p:nvGrpSpPr>
          <p:grpSpPr>
            <a:xfrm>
              <a:off x="6522987" y="1112596"/>
              <a:ext cx="140524" cy="229732"/>
              <a:chOff x="5593711" y="5353149"/>
              <a:chExt cx="120659" cy="375023"/>
            </a:xfrm>
          </p:grpSpPr>
          <p:cxnSp>
            <p:nvCxnSpPr>
              <p:cNvPr id="112" name="直線コネクタ 111">
                <a:extLst>
                  <a:ext uri="{FF2B5EF4-FFF2-40B4-BE49-F238E27FC236}">
                    <a16:creationId xmlns:a16="http://schemas.microsoft.com/office/drawing/2014/main" xmlns="" id="{DBD3769C-9378-4480-8767-4FF0DE0303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14365" y="5353149"/>
                <a:ext cx="0" cy="3750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>
                <a:extLst>
                  <a:ext uri="{FF2B5EF4-FFF2-40B4-BE49-F238E27FC236}">
                    <a16:creationId xmlns:a16="http://schemas.microsoft.com/office/drawing/2014/main" xmlns="" id="{78E5ED93-FBC0-4FE0-98AC-2C12E4A633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97947" y="5353374"/>
                <a:ext cx="11642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線コネクタ 113">
                <a:extLst>
                  <a:ext uri="{FF2B5EF4-FFF2-40B4-BE49-F238E27FC236}">
                    <a16:creationId xmlns:a16="http://schemas.microsoft.com/office/drawing/2014/main" xmlns="" id="{8DD3760E-42A2-4150-AD92-CD8CC035820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93711" y="5728171"/>
                <a:ext cx="120659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xmlns="" id="{5B24273A-B57C-43B5-AC9D-77178E4576FF}"/>
                </a:ext>
              </a:extLst>
            </p:cNvPr>
            <p:cNvSpPr txBox="1"/>
            <p:nvPr/>
          </p:nvSpPr>
          <p:spPr>
            <a:xfrm>
              <a:off x="6622915" y="1080710"/>
              <a:ext cx="376581" cy="31876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ja-JP" altLang="en-US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r>
                <a:rPr lang="en-US" altLang="ja-JP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ja-JP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1AECA34-1531-43AA-AA84-AB6E31BA6DF4}"/>
              </a:ext>
            </a:extLst>
          </p:cNvPr>
          <p:cNvSpPr txBox="1"/>
          <p:nvPr/>
        </p:nvSpPr>
        <p:spPr>
          <a:xfrm>
            <a:off x="5483355" y="1443479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04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6E18E6DF-BDCA-4089-9CD8-168B4A635254}"/>
              </a:ext>
            </a:extLst>
          </p:cNvPr>
          <p:cNvSpPr txBox="1"/>
          <p:nvPr/>
        </p:nvSpPr>
        <p:spPr>
          <a:xfrm>
            <a:off x="5483355" y="4640293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13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2F46BF38-AAB8-4D7A-975C-043D6748859B}"/>
              </a:ext>
            </a:extLst>
          </p:cNvPr>
          <p:cNvSpPr txBox="1"/>
          <p:nvPr/>
        </p:nvSpPr>
        <p:spPr>
          <a:xfrm>
            <a:off x="5488569" y="7092841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38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F1827078-BEF8-425B-B38D-A6BAFCEF29E4}"/>
              </a:ext>
            </a:extLst>
          </p:cNvPr>
          <p:cNvSpPr txBox="1"/>
          <p:nvPr/>
        </p:nvSpPr>
        <p:spPr>
          <a:xfrm>
            <a:off x="2141056" y="4638627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29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6EF88F1D-9B6B-44C8-B771-4F71D990F79E}"/>
              </a:ext>
            </a:extLst>
          </p:cNvPr>
          <p:cNvSpPr txBox="1"/>
          <p:nvPr/>
        </p:nvSpPr>
        <p:spPr>
          <a:xfrm>
            <a:off x="2140857" y="7094194"/>
            <a:ext cx="105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58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618302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5</TotalTime>
  <Words>256</Words>
  <Application>Microsoft Office PowerPoint</Application>
  <PresentationFormat>A4 Paper (210x297 mm)</PresentationFormat>
  <Paragraphs>20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庄田 勝俊</dc:creator>
  <cp:lastModifiedBy>SBUCOL</cp:lastModifiedBy>
  <cp:revision>85</cp:revision>
  <cp:lastPrinted>2020-07-02T14:53:20Z</cp:lastPrinted>
  <dcterms:created xsi:type="dcterms:W3CDTF">2019-03-25T10:47:55Z</dcterms:created>
  <dcterms:modified xsi:type="dcterms:W3CDTF">2020-08-23T23:58:36Z</dcterms:modified>
</cp:coreProperties>
</file>